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794500" cy="99314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03" userDrawn="1">
          <p15:clr>
            <a:srgbClr val="A4A3A4"/>
          </p15:clr>
        </p15:guide>
        <p15:guide id="2" pos="89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 showGuides="1">
      <p:cViewPr varScale="1">
        <p:scale>
          <a:sx n="124" d="100"/>
          <a:sy n="124" d="100"/>
        </p:scale>
        <p:origin x="668" y="88"/>
      </p:cViewPr>
      <p:guideLst>
        <p:guide orient="horz" pos="2903"/>
        <p:guide pos="89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72BDD-2822-4B87-8160-F58060773C9E}" type="datetimeFigureOut">
              <a:rPr lang="fr-FR" smtClean="0"/>
              <a:t>31/08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ABE00-D891-4902-8E0C-D77E65954A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41798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72BDD-2822-4B87-8160-F58060773C9E}" type="datetimeFigureOut">
              <a:rPr lang="fr-FR" smtClean="0"/>
              <a:t>31/08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ABE00-D891-4902-8E0C-D77E65954A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14569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72BDD-2822-4B87-8160-F58060773C9E}" type="datetimeFigureOut">
              <a:rPr lang="fr-FR" smtClean="0"/>
              <a:t>31/08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ABE00-D891-4902-8E0C-D77E65954A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69412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72BDD-2822-4B87-8160-F58060773C9E}" type="datetimeFigureOut">
              <a:rPr lang="fr-FR" smtClean="0"/>
              <a:t>31/08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ABE00-D891-4902-8E0C-D77E65954A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71545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72BDD-2822-4B87-8160-F58060773C9E}" type="datetimeFigureOut">
              <a:rPr lang="fr-FR" smtClean="0"/>
              <a:t>31/08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ABE00-D891-4902-8E0C-D77E65954A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05054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72BDD-2822-4B87-8160-F58060773C9E}" type="datetimeFigureOut">
              <a:rPr lang="fr-FR" smtClean="0"/>
              <a:t>31/08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ABE00-D891-4902-8E0C-D77E65954A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41930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72BDD-2822-4B87-8160-F58060773C9E}" type="datetimeFigureOut">
              <a:rPr lang="fr-FR" smtClean="0"/>
              <a:t>31/08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ABE00-D891-4902-8E0C-D77E65954A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61265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72BDD-2822-4B87-8160-F58060773C9E}" type="datetimeFigureOut">
              <a:rPr lang="fr-FR" smtClean="0"/>
              <a:t>31/08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ABE00-D891-4902-8E0C-D77E65954A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12389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72BDD-2822-4B87-8160-F58060773C9E}" type="datetimeFigureOut">
              <a:rPr lang="fr-FR" smtClean="0"/>
              <a:t>31/08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ABE00-D891-4902-8E0C-D77E65954A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0444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72BDD-2822-4B87-8160-F58060773C9E}" type="datetimeFigureOut">
              <a:rPr lang="fr-FR" smtClean="0"/>
              <a:t>31/08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ABE00-D891-4902-8E0C-D77E65954A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31564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72BDD-2822-4B87-8160-F58060773C9E}" type="datetimeFigureOut">
              <a:rPr lang="fr-FR" smtClean="0"/>
              <a:t>31/08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EABE00-D891-4902-8E0C-D77E65954A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3874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472BDD-2822-4B87-8160-F58060773C9E}" type="datetimeFigureOut">
              <a:rPr lang="fr-FR" smtClean="0"/>
              <a:t>31/08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EABE00-D891-4902-8E0C-D77E65954A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05079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ZoneTexte 95"/>
          <p:cNvSpPr txBox="1"/>
          <p:nvPr/>
        </p:nvSpPr>
        <p:spPr>
          <a:xfrm>
            <a:off x="4055845" y="0"/>
            <a:ext cx="28035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UY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b="1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fr-FR" b="1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fr-F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149974" y="6462482"/>
            <a:ext cx="65580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Viability (%) of Mutu-1 cells assessed by MTT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</a:rPr>
              <a:t>assay after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a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</a:rPr>
              <a:t>48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h treatment with DMSO (control) or various concentrations of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</a:rPr>
              <a:t>AMI-1, MTA or MS023. </a:t>
            </a:r>
            <a:r>
              <a:rPr lang="en-GB" sz="1200" dirty="0" smtClean="0">
                <a:latin typeface="Arial" panose="020B0604020202020204" pitchFamily="34" charset="0"/>
                <a:ea typeface="Times New Roman" panose="02020603050405020304" pitchFamily="18" charset="0"/>
              </a:rPr>
              <a:t>Data 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</a:rPr>
              <a:t>from two biological </a:t>
            </a:r>
            <a:r>
              <a:rPr lang="en-GB" sz="1200" dirty="0" smtClean="0">
                <a:latin typeface="Arial" panose="020B0604020202020204" pitchFamily="34" charset="0"/>
                <a:ea typeface="Times New Roman" panose="02020603050405020304" pitchFamily="18" charset="0"/>
              </a:rPr>
              <a:t>replicates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ns, not significant; *, p &lt; 0.05; ***, p &lt; 0.0001).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3199" y="772890"/>
            <a:ext cx="2808326" cy="25697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1905" y="772890"/>
            <a:ext cx="2797483" cy="25697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30259" y="3544664"/>
            <a:ext cx="2797483" cy="25697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90160902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6</TotalTime>
  <Words>54</Words>
  <Application>Microsoft Office PowerPoint</Application>
  <PresentationFormat>Affichage à l'écran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c Blondel</dc:creator>
  <cp:lastModifiedBy>Compte Microsoft</cp:lastModifiedBy>
  <cp:revision>46</cp:revision>
  <cp:lastPrinted>2020-10-26T17:45:59Z</cp:lastPrinted>
  <dcterms:created xsi:type="dcterms:W3CDTF">2020-04-16T17:45:46Z</dcterms:created>
  <dcterms:modified xsi:type="dcterms:W3CDTF">2022-08-31T16:51:47Z</dcterms:modified>
</cp:coreProperties>
</file>